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755EEB-0653-4272-AA98-71DD1FE5C1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7F7292-D18E-4B63-AC60-65B97F781C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9BBF42-8AAB-498C-9BF0-B5062D94A31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623C2F-0F8E-4461-BF83-7DFBDF4756E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AEF82C-0701-4FDF-88C6-D4110CCA48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1810E7-2C34-4FCA-810A-C6546B06AC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BBB175-9C32-4CB8-BCCE-0540D33124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015FCF-38A7-4CEE-A73D-B1AEC8170A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61CE27-8315-41E7-A4BF-68C205F20C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E216EB-36B5-4025-8C0E-0C70889EA4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3FEC50-1D51-4EE2-AEFD-C01AED7EDF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B4A3A0-8824-4AF0-A52D-D756EFB501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A736C1-E99B-4BDD-82F8-F01F1E63E70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image" Target="../media/image10.wmf"/><Relationship Id="rId3" Type="http://schemas.openxmlformats.org/officeDocument/2006/relationships/package" Target="../embeddings/oleObject1.xlsx"/><Relationship Id="rId4" Type="http://schemas.openxmlformats.org/officeDocument/2006/relationships/image" Target="../media/image11.wmf"/><Relationship Id="rId5" Type="http://schemas.openxmlformats.org/officeDocument/2006/relationships/image" Target="../media/image12.wmf"/><Relationship Id="rId6" Type="http://schemas.openxmlformats.org/officeDocument/2006/relationships/image" Target="../media/image13.wmf"/><Relationship Id="rId7" Type="http://schemas.openxmlformats.org/officeDocument/2006/relationships/image" Target="../media/image14.wmf"/><Relationship Id="rId8" Type="http://schemas.openxmlformats.org/officeDocument/2006/relationships/image" Target="../media/image15.wmf"/><Relationship Id="rId9" Type="http://schemas.openxmlformats.org/officeDocument/2006/relationships/image" Target="../media/image16.wmf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17360" y="100800"/>
            <a:ext cx="2949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Supplementary Figure 1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404640" y="712800"/>
            <a:ext cx="2779920" cy="1820880"/>
            <a:chOff x="404640" y="712800"/>
            <a:chExt cx="2779920" cy="1820880"/>
          </a:xfrm>
        </p:grpSpPr>
        <p:pic>
          <p:nvPicPr>
            <p:cNvPr id="43" name="" descr=""/>
            <p:cNvPicPr/>
            <p:nvPr/>
          </p:nvPicPr>
          <p:blipFill>
            <a:blip r:embed="rId1"/>
            <a:stretch/>
          </p:blipFill>
          <p:spPr>
            <a:xfrm>
              <a:off x="404640" y="712800"/>
              <a:ext cx="2779920" cy="182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"/>
            <p:cNvSpPr/>
            <p:nvPr/>
          </p:nvSpPr>
          <p:spPr>
            <a:xfrm>
              <a:off x="1163520" y="200988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031840" y="176220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199160" y="2289240"/>
              <a:ext cx="470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q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046240" y="2284560"/>
              <a:ext cx="51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q g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620640" y="2049480"/>
              <a:ext cx="59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=0.00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" name=""/>
          <p:cNvGrpSpPr/>
          <p:nvPr/>
        </p:nvGrpSpPr>
        <p:grpSpPr>
          <a:xfrm>
            <a:off x="3570120" y="733320"/>
            <a:ext cx="2803680" cy="1842840"/>
            <a:chOff x="3570120" y="733320"/>
            <a:chExt cx="2803680" cy="1842840"/>
          </a:xfrm>
        </p:grpSpPr>
        <p:pic>
          <p:nvPicPr>
            <p:cNvPr id="50" name="" descr=""/>
            <p:cNvPicPr/>
            <p:nvPr/>
          </p:nvPicPr>
          <p:blipFill>
            <a:blip r:embed="rId2"/>
            <a:stretch/>
          </p:blipFill>
          <p:spPr>
            <a:xfrm>
              <a:off x="3570120" y="733320"/>
              <a:ext cx="2803680" cy="1842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"/>
            <p:cNvSpPr/>
            <p:nvPr/>
          </p:nvSpPr>
          <p:spPr>
            <a:xfrm>
              <a:off x="4416120" y="179388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5224320" y="159696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432680" y="2315880"/>
              <a:ext cx="470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q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279760" y="2311200"/>
              <a:ext cx="51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q g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875040" y="2092320"/>
              <a:ext cx="59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=0.00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6" name=""/>
          <p:cNvGrpSpPr/>
          <p:nvPr/>
        </p:nvGrpSpPr>
        <p:grpSpPr>
          <a:xfrm>
            <a:off x="404640" y="2681280"/>
            <a:ext cx="2811600" cy="1851120"/>
            <a:chOff x="404640" y="2681280"/>
            <a:chExt cx="2811600" cy="1851120"/>
          </a:xfrm>
        </p:grpSpPr>
        <p:pic>
          <p:nvPicPr>
            <p:cNvPr id="57" name="" descr=""/>
            <p:cNvPicPr/>
            <p:nvPr/>
          </p:nvPicPr>
          <p:blipFill>
            <a:blip r:embed="rId3"/>
            <a:stretch/>
          </p:blipFill>
          <p:spPr>
            <a:xfrm>
              <a:off x="404640" y="2681280"/>
              <a:ext cx="2811600" cy="1851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"/>
            <p:cNvSpPr/>
            <p:nvPr/>
          </p:nvSpPr>
          <p:spPr>
            <a:xfrm>
              <a:off x="1246320" y="3934080"/>
              <a:ext cx="6109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077920" y="370548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218240" y="4270320"/>
              <a:ext cx="470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q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077920" y="4265640"/>
              <a:ext cx="51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q g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711360" y="4033800"/>
              <a:ext cx="59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&lt;0.00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3" name=""/>
          <p:cNvGrpSpPr/>
          <p:nvPr/>
        </p:nvGrpSpPr>
        <p:grpSpPr>
          <a:xfrm>
            <a:off x="3570120" y="2727360"/>
            <a:ext cx="2811240" cy="1851120"/>
            <a:chOff x="3570120" y="2727360"/>
            <a:chExt cx="2811240" cy="1851120"/>
          </a:xfrm>
        </p:grpSpPr>
        <p:pic>
          <p:nvPicPr>
            <p:cNvPr id="64" name="" descr=""/>
            <p:cNvPicPr/>
            <p:nvPr/>
          </p:nvPicPr>
          <p:blipFill>
            <a:blip r:embed="rId4"/>
            <a:stretch/>
          </p:blipFill>
          <p:spPr>
            <a:xfrm>
              <a:off x="3570120" y="2727360"/>
              <a:ext cx="2811240" cy="1851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"/>
            <p:cNvSpPr/>
            <p:nvPr/>
          </p:nvSpPr>
          <p:spPr>
            <a:xfrm>
              <a:off x="4381200" y="3816360"/>
              <a:ext cx="6112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5230440" y="3637080"/>
              <a:ext cx="6112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367880" y="426888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3q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5227560" y="4264200"/>
              <a:ext cx="57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3q g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795480" y="4096080"/>
              <a:ext cx="59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&lt;0.00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0" name=""/>
          <p:cNvGrpSpPr/>
          <p:nvPr/>
        </p:nvGrpSpPr>
        <p:grpSpPr>
          <a:xfrm>
            <a:off x="404640" y="4680000"/>
            <a:ext cx="2821320" cy="1860480"/>
            <a:chOff x="404640" y="4680000"/>
            <a:chExt cx="2821320" cy="1860480"/>
          </a:xfrm>
        </p:grpSpPr>
        <p:pic>
          <p:nvPicPr>
            <p:cNvPr id="71" name="" descr=""/>
            <p:cNvPicPr/>
            <p:nvPr/>
          </p:nvPicPr>
          <p:blipFill>
            <a:blip r:embed="rId5"/>
            <a:stretch/>
          </p:blipFill>
          <p:spPr>
            <a:xfrm>
              <a:off x="404640" y="4680000"/>
              <a:ext cx="2821320" cy="1860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"/>
            <p:cNvSpPr/>
            <p:nvPr/>
          </p:nvSpPr>
          <p:spPr>
            <a:xfrm>
              <a:off x="1235160" y="5818320"/>
              <a:ext cx="6109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062080" y="5614920"/>
              <a:ext cx="6112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262880" y="627552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3q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109960" y="6270840"/>
              <a:ext cx="57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3q g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693720" y="6058080"/>
              <a:ext cx="59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=0.00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" name=""/>
          <p:cNvGrpSpPr/>
          <p:nvPr/>
        </p:nvGrpSpPr>
        <p:grpSpPr>
          <a:xfrm>
            <a:off x="3570120" y="4729320"/>
            <a:ext cx="2808360" cy="1800000"/>
            <a:chOff x="3570120" y="4729320"/>
            <a:chExt cx="2808360" cy="1800000"/>
          </a:xfrm>
        </p:grpSpPr>
        <p:pic>
          <p:nvPicPr>
            <p:cNvPr id="78" name="" descr=""/>
            <p:cNvPicPr/>
            <p:nvPr/>
          </p:nvPicPr>
          <p:blipFill>
            <a:blip r:embed="rId6"/>
            <a:stretch/>
          </p:blipFill>
          <p:spPr>
            <a:xfrm>
              <a:off x="3570120" y="4729320"/>
              <a:ext cx="2808360" cy="180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"/>
            <p:cNvSpPr/>
            <p:nvPr/>
          </p:nvSpPr>
          <p:spPr>
            <a:xfrm>
              <a:off x="4419360" y="555444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259240" y="5796000"/>
              <a:ext cx="61128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418640" y="626580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8q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5264280" y="6261120"/>
              <a:ext cx="561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8q los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859200" y="6035400"/>
              <a:ext cx="59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&lt;0.00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4" name=""/>
          <p:cNvGrpSpPr/>
          <p:nvPr/>
        </p:nvGrpSpPr>
        <p:grpSpPr>
          <a:xfrm>
            <a:off x="404640" y="6689880"/>
            <a:ext cx="2803680" cy="1842840"/>
            <a:chOff x="404640" y="6689880"/>
            <a:chExt cx="2803680" cy="1842840"/>
          </a:xfrm>
        </p:grpSpPr>
        <p:pic>
          <p:nvPicPr>
            <p:cNvPr id="85" name="" descr=""/>
            <p:cNvPicPr/>
            <p:nvPr/>
          </p:nvPicPr>
          <p:blipFill>
            <a:blip r:embed="rId7"/>
            <a:stretch/>
          </p:blipFill>
          <p:spPr>
            <a:xfrm>
              <a:off x="404640" y="6689880"/>
              <a:ext cx="2803680" cy="1842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"/>
            <p:cNvSpPr/>
            <p:nvPr/>
          </p:nvSpPr>
          <p:spPr>
            <a:xfrm>
              <a:off x="1241280" y="785988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046240" y="754704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262880" y="826920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q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122560" y="8264520"/>
              <a:ext cx="57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q g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712800" y="8029440"/>
              <a:ext cx="59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&lt;0.00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1" name=""/>
          <p:cNvGrpSpPr/>
          <p:nvPr/>
        </p:nvGrpSpPr>
        <p:grpSpPr>
          <a:xfrm>
            <a:off x="3570120" y="6680160"/>
            <a:ext cx="2814480" cy="1852560"/>
            <a:chOff x="3570120" y="6680160"/>
            <a:chExt cx="2814480" cy="1852560"/>
          </a:xfrm>
        </p:grpSpPr>
        <p:pic>
          <p:nvPicPr>
            <p:cNvPr id="92" name="" descr=""/>
            <p:cNvPicPr/>
            <p:nvPr/>
          </p:nvPicPr>
          <p:blipFill>
            <a:blip r:embed="rId8"/>
            <a:stretch/>
          </p:blipFill>
          <p:spPr>
            <a:xfrm>
              <a:off x="3570120" y="6680160"/>
              <a:ext cx="2814480" cy="1852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3" name=""/>
            <p:cNvSpPr/>
            <p:nvPr/>
          </p:nvSpPr>
          <p:spPr>
            <a:xfrm>
              <a:off x="4437720" y="826452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q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5297400" y="8259480"/>
              <a:ext cx="57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q g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4400280" y="804384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5225760" y="762300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844800" y="8048520"/>
              <a:ext cx="59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&lt;0.00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"/>
          <p:cNvSpPr/>
          <p:nvPr/>
        </p:nvSpPr>
        <p:spPr>
          <a:xfrm>
            <a:off x="45720" y="-720"/>
            <a:ext cx="2949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Supplementary Figure 1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9" name=""/>
          <p:cNvGrpSpPr/>
          <p:nvPr/>
        </p:nvGrpSpPr>
        <p:grpSpPr>
          <a:xfrm>
            <a:off x="476280" y="755640"/>
            <a:ext cx="2811600" cy="1851120"/>
            <a:chOff x="476280" y="755640"/>
            <a:chExt cx="2811600" cy="1851120"/>
          </a:xfrm>
        </p:grpSpPr>
        <p:pic>
          <p:nvPicPr>
            <p:cNvPr id="100" name="" descr=""/>
            <p:cNvPicPr/>
            <p:nvPr/>
          </p:nvPicPr>
          <p:blipFill>
            <a:blip r:embed="rId1"/>
            <a:stretch/>
          </p:blipFill>
          <p:spPr>
            <a:xfrm>
              <a:off x="476280" y="755640"/>
              <a:ext cx="2811600" cy="1851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1" name=""/>
            <p:cNvSpPr/>
            <p:nvPr/>
          </p:nvSpPr>
          <p:spPr>
            <a:xfrm>
              <a:off x="1298520" y="200988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170080" y="187488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1343520" y="2344680"/>
              <a:ext cx="470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q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203200" y="2340000"/>
              <a:ext cx="51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q g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701640" y="2101680"/>
              <a:ext cx="59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=0.00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6" name=""/>
          <p:cNvGrpSpPr/>
          <p:nvPr/>
        </p:nvGrpSpPr>
        <p:grpSpPr>
          <a:xfrm>
            <a:off x="3429000" y="755640"/>
            <a:ext cx="2817720" cy="1859040"/>
            <a:chOff x="3429000" y="755640"/>
            <a:chExt cx="2817720" cy="1859040"/>
          </a:xfrm>
        </p:grpSpPr>
        <p:pic>
          <p:nvPicPr>
            <p:cNvPr id="107" name="" descr=""/>
            <p:cNvPicPr/>
            <p:nvPr/>
          </p:nvPicPr>
          <p:blipFill>
            <a:blip r:embed="rId2"/>
            <a:stretch/>
          </p:blipFill>
          <p:spPr>
            <a:xfrm>
              <a:off x="3429000" y="755640"/>
              <a:ext cx="2817720" cy="1859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8" name=""/>
            <p:cNvSpPr/>
            <p:nvPr/>
          </p:nvSpPr>
          <p:spPr>
            <a:xfrm>
              <a:off x="4294080" y="176688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5181480" y="164952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4308840" y="2362320"/>
              <a:ext cx="470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q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5168880" y="2357280"/>
              <a:ext cx="51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q g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722760" y="2090520"/>
              <a:ext cx="59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=0.06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3" name=""/>
          <p:cNvGrpSpPr/>
          <p:nvPr/>
        </p:nvGrpSpPr>
        <p:grpSpPr>
          <a:xfrm>
            <a:off x="476280" y="2782800"/>
            <a:ext cx="2795400" cy="1766880"/>
            <a:chOff x="476280" y="2782800"/>
            <a:chExt cx="2795400" cy="1766880"/>
          </a:xfrm>
        </p:grpSpPr>
        <p:graphicFrame>
          <p:nvGraphicFramePr>
            <p:cNvPr id="114" name=""/>
            <p:cNvGraphicFramePr/>
            <p:nvPr/>
          </p:nvGraphicFramePr>
          <p:xfrm>
            <a:off x="476280" y="2782800"/>
            <a:ext cx="2795400" cy="176688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115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476280" y="2782800"/>
                      <a:ext cx="2795400" cy="1766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16" name=""/>
            <p:cNvSpPr/>
            <p:nvPr/>
          </p:nvSpPr>
          <p:spPr>
            <a:xfrm>
              <a:off x="1271520" y="3895560"/>
              <a:ext cx="6112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2103480" y="381492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264320" y="4260960"/>
              <a:ext cx="470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q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124000" y="4255920"/>
              <a:ext cx="51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q g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701640" y="4057560"/>
              <a:ext cx="59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=0.03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1" name=""/>
          <p:cNvGrpSpPr/>
          <p:nvPr/>
        </p:nvGrpSpPr>
        <p:grpSpPr>
          <a:xfrm>
            <a:off x="3429000" y="2697120"/>
            <a:ext cx="2835000" cy="1874880"/>
            <a:chOff x="3429000" y="2697120"/>
            <a:chExt cx="2835000" cy="1874880"/>
          </a:xfrm>
        </p:grpSpPr>
        <p:pic>
          <p:nvPicPr>
            <p:cNvPr id="122" name="" descr=""/>
            <p:cNvPicPr/>
            <p:nvPr/>
          </p:nvPicPr>
          <p:blipFill>
            <a:blip r:embed="rId5"/>
            <a:stretch/>
          </p:blipFill>
          <p:spPr>
            <a:xfrm>
              <a:off x="3429000" y="2697120"/>
              <a:ext cx="2835000" cy="1874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3" name=""/>
            <p:cNvSpPr/>
            <p:nvPr/>
          </p:nvSpPr>
          <p:spPr>
            <a:xfrm>
              <a:off x="4230720" y="3845160"/>
              <a:ext cx="6109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5086080" y="3903840"/>
              <a:ext cx="611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226760" y="430704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3q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5086440" y="4302360"/>
              <a:ext cx="57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3q g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3656160" y="4079880"/>
              <a:ext cx="535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=0.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8" name=""/>
          <p:cNvGrpSpPr/>
          <p:nvPr/>
        </p:nvGrpSpPr>
        <p:grpSpPr>
          <a:xfrm>
            <a:off x="3429000" y="4716360"/>
            <a:ext cx="2808360" cy="1825560"/>
            <a:chOff x="3429000" y="4716360"/>
            <a:chExt cx="2808360" cy="1825560"/>
          </a:xfrm>
        </p:grpSpPr>
        <p:pic>
          <p:nvPicPr>
            <p:cNvPr id="129" name="" descr=""/>
            <p:cNvPicPr/>
            <p:nvPr/>
          </p:nvPicPr>
          <p:blipFill>
            <a:blip r:embed="rId6"/>
            <a:stretch/>
          </p:blipFill>
          <p:spPr>
            <a:xfrm>
              <a:off x="3429000" y="4716360"/>
              <a:ext cx="2808360" cy="1825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0" name=""/>
            <p:cNvSpPr/>
            <p:nvPr/>
          </p:nvSpPr>
          <p:spPr>
            <a:xfrm>
              <a:off x="4271040" y="5573520"/>
              <a:ext cx="5788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5125680" y="5684760"/>
              <a:ext cx="5788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4306320" y="627228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8q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5119920" y="6267240"/>
              <a:ext cx="561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8q los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3652920" y="6056280"/>
              <a:ext cx="59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=0.00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5" name=""/>
          <p:cNvGrpSpPr/>
          <p:nvPr/>
        </p:nvGrpSpPr>
        <p:grpSpPr>
          <a:xfrm>
            <a:off x="476280" y="6681960"/>
            <a:ext cx="2808360" cy="1850760"/>
            <a:chOff x="476280" y="6681960"/>
            <a:chExt cx="2808360" cy="1850760"/>
          </a:xfrm>
        </p:grpSpPr>
        <p:pic>
          <p:nvPicPr>
            <p:cNvPr id="136" name="" descr=""/>
            <p:cNvPicPr/>
            <p:nvPr/>
          </p:nvPicPr>
          <p:blipFill>
            <a:blip r:embed="rId7"/>
            <a:stretch/>
          </p:blipFill>
          <p:spPr>
            <a:xfrm>
              <a:off x="476280" y="6681960"/>
              <a:ext cx="2808360" cy="1850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7" name=""/>
            <p:cNvSpPr/>
            <p:nvPr/>
          </p:nvSpPr>
          <p:spPr>
            <a:xfrm>
              <a:off x="1346400" y="7588080"/>
              <a:ext cx="57492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2215440" y="7537320"/>
              <a:ext cx="57492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1392840" y="825012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8q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2198520" y="8253360"/>
              <a:ext cx="561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8q los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749520" y="8021520"/>
              <a:ext cx="59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=0.02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2" name=""/>
          <p:cNvGrpSpPr/>
          <p:nvPr/>
        </p:nvGrpSpPr>
        <p:grpSpPr>
          <a:xfrm>
            <a:off x="476280" y="4727520"/>
            <a:ext cx="2808360" cy="1776600"/>
            <a:chOff x="476280" y="4727520"/>
            <a:chExt cx="2808360" cy="1776600"/>
          </a:xfrm>
        </p:grpSpPr>
        <p:pic>
          <p:nvPicPr>
            <p:cNvPr id="143" name="" descr=""/>
            <p:cNvPicPr/>
            <p:nvPr/>
          </p:nvPicPr>
          <p:blipFill>
            <a:blip r:embed="rId8"/>
            <a:stretch/>
          </p:blipFill>
          <p:spPr>
            <a:xfrm>
              <a:off x="476280" y="4727520"/>
              <a:ext cx="2808360" cy="1776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4" name=""/>
            <p:cNvSpPr/>
            <p:nvPr/>
          </p:nvSpPr>
          <p:spPr>
            <a:xfrm>
              <a:off x="1253520" y="5859360"/>
              <a:ext cx="5763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2084760" y="5871960"/>
              <a:ext cx="5767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299240" y="625320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7p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2108520" y="6248520"/>
              <a:ext cx="561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7p los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690840" y="6018120"/>
              <a:ext cx="59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=0.18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9" name=""/>
          <p:cNvGrpSpPr/>
          <p:nvPr/>
        </p:nvGrpSpPr>
        <p:grpSpPr>
          <a:xfrm>
            <a:off x="3429000" y="6673680"/>
            <a:ext cx="2808360" cy="1859040"/>
            <a:chOff x="3429000" y="6673680"/>
            <a:chExt cx="2808360" cy="1859040"/>
          </a:xfrm>
        </p:grpSpPr>
        <p:pic>
          <p:nvPicPr>
            <p:cNvPr id="150" name="" descr=""/>
            <p:cNvPicPr/>
            <p:nvPr/>
          </p:nvPicPr>
          <p:blipFill>
            <a:blip r:embed="rId9"/>
            <a:stretch/>
          </p:blipFill>
          <p:spPr>
            <a:xfrm>
              <a:off x="3429000" y="6673680"/>
              <a:ext cx="2808360" cy="1859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1" name=""/>
            <p:cNvSpPr/>
            <p:nvPr/>
          </p:nvSpPr>
          <p:spPr>
            <a:xfrm>
              <a:off x="4210560" y="7777080"/>
              <a:ext cx="5763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4982040" y="7759800"/>
              <a:ext cx="5763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4202280" y="826128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q re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5013360" y="8256600"/>
              <a:ext cx="57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q ga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3652200" y="8037360"/>
              <a:ext cx="59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=0.06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8-06T06:28:57Z</dcterms:created>
  <dc:creator>lipse</dc:creator>
  <dc:description/>
  <dc:language>en-US</dc:language>
  <cp:lastModifiedBy>lipse</cp:lastModifiedBy>
  <dcterms:modified xsi:type="dcterms:W3CDTF">2008-08-18T17:00:04Z</dcterms:modified>
  <cp:revision>10</cp:revision>
  <dc:subject/>
  <dc:title>Slide 1</dc:title>
</cp:coreProperties>
</file>